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8202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C7AF88-6DD1-4A2A-968D-0D8A76361B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DA9C0F-A88F-4E9E-A0A2-5A306378F7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DF642-327F-4FF8-9D08-C24A381B82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F93E24-3C1C-43E5-901C-BCE85E6122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821700-B24C-4D81-9DF5-3C270D5B51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35DED-4E57-49B6-AE1A-16ECEC2320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B5B9B6-13C3-49C9-BAE4-C48986587B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0E0525-47C0-4B07-B02E-17C1AD5E0D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CDE16F-A1AA-4501-BCA7-0C9738D8D9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41F7B-2739-4ACB-A109-14952C16A5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3F251-77FD-491B-BD1D-89BA425AA9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FDF522-9F3F-4B73-B465-803E18F1FB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90787E-15AD-4161-825E-98B379AF07DB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package" Target="../embeddings/oleObject2.xlsx"/><Relationship Id="rId5" Type="http://schemas.openxmlformats.org/officeDocument/2006/relationships/image" Target="../media/image3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9"/>
          <p:cNvSpPr/>
          <p:nvPr/>
        </p:nvSpPr>
        <p:spPr>
          <a:xfrm>
            <a:off x="2644920" y="76320"/>
            <a:ext cx="2059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Pre-puberal AS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6"/>
          <p:cNvSpPr/>
          <p:nvPr/>
        </p:nvSpPr>
        <p:spPr>
          <a:xfrm>
            <a:off x="-2835360" y="4643280"/>
            <a:ext cx="432000" cy="39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32"/>
          <p:cNvSpPr/>
          <p:nvPr/>
        </p:nvSpPr>
        <p:spPr>
          <a:xfrm>
            <a:off x="-2116080" y="6516720"/>
            <a:ext cx="50472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Object 53"/>
          <p:cNvGraphicFramePr/>
          <p:nvPr/>
        </p:nvGraphicFramePr>
        <p:xfrm>
          <a:off x="334800" y="395280"/>
          <a:ext cx="3267360" cy="14400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5" name="Object 5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34800" y="395280"/>
                    <a:ext cx="3267360" cy="14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46" name="Object 54" descr=""/>
          <p:cNvPicPr/>
          <p:nvPr/>
        </p:nvPicPr>
        <p:blipFill>
          <a:blip r:embed="rId3"/>
          <a:stretch/>
        </p:blipFill>
        <p:spPr>
          <a:xfrm>
            <a:off x="216000" y="1868400"/>
            <a:ext cx="3384360" cy="15699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7" name="Object 55"/>
          <p:cNvGraphicFramePr/>
          <p:nvPr/>
        </p:nvGraphicFramePr>
        <p:xfrm>
          <a:off x="3575160" y="1984320"/>
          <a:ext cx="3246480" cy="1382760"/>
        </p:xfrm>
        <a:graphic>
          <a:graphicData uri="http://schemas.openxmlformats.org/presentationml/2006/ole">
            <p:oleObj progId="Excel.Sheet.12" r:id="rId4" spid="">
              <p:embed/>
              <p:pic>
                <p:nvPicPr>
                  <p:cNvPr id="48" name="Object 55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3575160" y="1984320"/>
                    <a:ext cx="3246480" cy="1382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9" name="Text Box 65"/>
          <p:cNvSpPr/>
          <p:nvPr/>
        </p:nvSpPr>
        <p:spPr>
          <a:xfrm>
            <a:off x="3246480" y="382680"/>
            <a:ext cx="28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66"/>
          <p:cNvSpPr/>
          <p:nvPr/>
        </p:nvSpPr>
        <p:spPr>
          <a:xfrm>
            <a:off x="3168720" y="1933560"/>
            <a:ext cx="36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67"/>
          <p:cNvSpPr/>
          <p:nvPr/>
        </p:nvSpPr>
        <p:spPr>
          <a:xfrm>
            <a:off x="6453360" y="1933560"/>
            <a:ext cx="2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78"/>
          <p:cNvSpPr/>
          <p:nvPr/>
        </p:nvSpPr>
        <p:spPr>
          <a:xfrm rot="16200000">
            <a:off x="-398520" y="939960"/>
            <a:ext cx="114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% methyl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79"/>
          <p:cNvSpPr/>
          <p:nvPr/>
        </p:nvSpPr>
        <p:spPr>
          <a:xfrm rot="16200000">
            <a:off x="-405000" y="2481480"/>
            <a:ext cx="114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% methyl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"/>
          <p:cNvGraphicFramePr/>
          <p:nvPr/>
        </p:nvGraphicFramePr>
        <p:xfrm>
          <a:off x="343080" y="4078440"/>
          <a:ext cx="6172200" cy="1892160"/>
        </p:xfrm>
        <a:graphic>
          <a:graphicData uri="http://schemas.openxmlformats.org/drawingml/2006/table">
            <a:tbl>
              <a:tblPr/>
              <a:tblGrid>
                <a:gridCol w="234720"/>
                <a:gridCol w="619200"/>
                <a:gridCol w="503280"/>
                <a:gridCol w="504720"/>
                <a:gridCol w="327240"/>
                <a:gridCol w="249120"/>
                <a:gridCol w="360360"/>
                <a:gridCol w="531720"/>
                <a:gridCol w="619200"/>
                <a:gridCol w="504720"/>
                <a:gridCol w="816120"/>
                <a:gridCol w="901800"/>
              </a:tblGrid>
              <a:tr h="411120"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se No.</a:t>
                      </a:r>
                      <a:r>
                        <a:rPr b="0" lang="en-GB" sz="8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rodman are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iagnosi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e  (yrs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x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MI  (hrs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use of deat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ellectual Disability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pileps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ther features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rug therapies at time of death</a:t>
                      </a:r>
                      <a:r>
                        <a:rPr b="0" lang="en-GB" sz="8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4120"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08873 (B5569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DD-NO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rown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current otitis, angioedema, food allergi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zac, melaton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74520"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MB11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utis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dden death, seizur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182520"/>
                          <a:tab algn="l" pos="449280"/>
                          <a:tab algn="dec" pos="4572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358136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loboma iris, cortical heterotopias, mesial temporal sclerosis, lymphoadenopathy, recurrent infectio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mictal, Valiu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2400"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MB47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utis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rown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360" rIns="453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76"/>
                        </a:spcBef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5360" marR="45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5" name="CasellaDiTesto 4"/>
          <p:cNvSpPr/>
          <p:nvPr/>
        </p:nvSpPr>
        <p:spPr>
          <a:xfrm>
            <a:off x="557640" y="334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CasellaDiTesto 5"/>
          <p:cNvSpPr/>
          <p:nvPr/>
        </p:nvSpPr>
        <p:spPr>
          <a:xfrm>
            <a:off x="426600" y="3564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01T07:14:22Z</dcterms:created>
  <dc:creator>c.lintas</dc:creator>
  <dc:description/>
  <dc:language>en-US</dc:language>
  <cp:lastModifiedBy>aaa</cp:lastModifiedBy>
  <cp:lastPrinted>2015-12-18T10:11:19Z</cp:lastPrinted>
  <dcterms:modified xsi:type="dcterms:W3CDTF">2016-02-10T17:34:26Z</dcterms:modified>
  <cp:revision>76</cp:revision>
  <dc:subject/>
  <dc:title>Diapositiva 1</dc:title>
</cp:coreProperties>
</file>